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7315200" cy="96012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1632" y="-24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ECF3E797-3098-49CF-B5DA-910C3CA640E0}" type="datetimeFigureOut">
              <a:rPr lang="it-IT" smtClean="0"/>
              <a:pPr/>
              <a:t>05/04/2011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06638" y="720725"/>
            <a:ext cx="2701925" cy="3600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731520" y="4560570"/>
            <a:ext cx="5852160" cy="4320540"/>
          </a:xfrm>
          <a:prstGeom prst="rect">
            <a:avLst/>
          </a:prstGeom>
        </p:spPr>
        <p:txBody>
          <a:bodyPr vert="horz" lIns="96661" tIns="48331" rIns="96661" bIns="48331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37A66373-4D1B-41E9-A910-AB42DBFEAD17}" type="slidenum">
              <a:rPr lang="it-IT" smtClean="0"/>
              <a:pPr/>
              <a:t>‹#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>
          <a:xfrm>
            <a:off x="2306638" y="720725"/>
            <a:ext cx="2701925" cy="3600450"/>
          </a:xfrm>
        </p:spPr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7A66373-4D1B-41E9-A910-AB42DBFEAD17}" type="slidenum">
              <a:rPr lang="it-IT" smtClean="0"/>
              <a:pPr/>
              <a:t>1</a:t>
            </a:fld>
            <a:endParaRPr lang="it-IT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785-7F71-46F5-AB0D-02122B642D79}" type="datetimeFigureOut">
              <a:rPr lang="it-IT" smtClean="0"/>
              <a:pPr/>
              <a:t>05/04/201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0BF0C-E849-40C0-A801-6425B6794E84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785-7F71-46F5-AB0D-02122B642D79}" type="datetimeFigureOut">
              <a:rPr lang="it-IT" smtClean="0"/>
              <a:pPr/>
              <a:t>05/04/201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0BF0C-E849-40C0-A801-6425B6794E84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785-7F71-46F5-AB0D-02122B642D79}" type="datetimeFigureOut">
              <a:rPr lang="it-IT" smtClean="0"/>
              <a:pPr/>
              <a:t>05/04/201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0BF0C-E849-40C0-A801-6425B6794E84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785-7F71-46F5-AB0D-02122B642D79}" type="datetimeFigureOut">
              <a:rPr lang="it-IT" smtClean="0"/>
              <a:pPr/>
              <a:t>05/04/201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0BF0C-E849-40C0-A801-6425B6794E84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785-7F71-46F5-AB0D-02122B642D79}" type="datetimeFigureOut">
              <a:rPr lang="it-IT" smtClean="0"/>
              <a:pPr/>
              <a:t>05/04/201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0BF0C-E849-40C0-A801-6425B6794E84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785-7F71-46F5-AB0D-02122B642D79}" type="datetimeFigureOut">
              <a:rPr lang="it-IT" smtClean="0"/>
              <a:pPr/>
              <a:t>05/04/201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0BF0C-E849-40C0-A801-6425B6794E84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785-7F71-46F5-AB0D-02122B642D79}" type="datetimeFigureOut">
              <a:rPr lang="it-IT" smtClean="0"/>
              <a:pPr/>
              <a:t>05/04/2011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0BF0C-E849-40C0-A801-6425B6794E84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785-7F71-46F5-AB0D-02122B642D79}" type="datetimeFigureOut">
              <a:rPr lang="it-IT" smtClean="0"/>
              <a:pPr/>
              <a:t>05/04/2011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0BF0C-E849-40C0-A801-6425B6794E84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785-7F71-46F5-AB0D-02122B642D79}" type="datetimeFigureOut">
              <a:rPr lang="it-IT" smtClean="0"/>
              <a:pPr/>
              <a:t>05/04/2011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0BF0C-E849-40C0-A801-6425B6794E84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785-7F71-46F5-AB0D-02122B642D79}" type="datetimeFigureOut">
              <a:rPr lang="it-IT" smtClean="0"/>
              <a:pPr/>
              <a:t>05/04/201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0BF0C-E849-40C0-A801-6425B6794E84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C6785-7F71-46F5-AB0D-02122B642D79}" type="datetimeFigureOut">
              <a:rPr lang="it-IT" smtClean="0"/>
              <a:pPr/>
              <a:t>05/04/201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0BF0C-E849-40C0-A801-6425B6794E84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3C6785-7F71-46F5-AB0D-02122B642D79}" type="datetimeFigureOut">
              <a:rPr lang="it-IT" smtClean="0"/>
              <a:pPr/>
              <a:t>05/04/201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50BF0C-E849-40C0-A801-6425B6794E84}" type="slidenum">
              <a:rPr lang="it-IT" smtClean="0"/>
              <a:pPr/>
              <a:t>‹#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ella 7"/>
          <p:cNvGraphicFramePr>
            <a:graphicFrameLocks noGrp="1"/>
          </p:cNvGraphicFramePr>
          <p:nvPr/>
        </p:nvGraphicFramePr>
        <p:xfrm>
          <a:off x="692696" y="1403646"/>
          <a:ext cx="5616626" cy="5769300"/>
        </p:xfrm>
        <a:graphic>
          <a:graphicData uri="http://schemas.openxmlformats.org/drawingml/2006/table">
            <a:tbl>
              <a:tblPr/>
              <a:tblGrid>
                <a:gridCol w="576067"/>
                <a:gridCol w="1512165"/>
                <a:gridCol w="936104"/>
                <a:gridCol w="936104"/>
                <a:gridCol w="885289"/>
                <a:gridCol w="770897"/>
              </a:tblGrid>
              <a:tr h="360042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1200" dirty="0"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5"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 smtClean="0">
                          <a:latin typeface="Arial"/>
                          <a:ea typeface="Calibri"/>
                          <a:cs typeface="Times New Roman"/>
                        </a:rPr>
                        <a:t>Table </a:t>
                      </a:r>
                      <a:r>
                        <a:rPr lang="en-US" sz="1200" b="1" dirty="0">
                          <a:latin typeface="Arial"/>
                          <a:ea typeface="Calibri"/>
                          <a:cs typeface="Times New Roman"/>
                        </a:rPr>
                        <a:t>S1</a:t>
                      </a:r>
                      <a:r>
                        <a:rPr lang="en-US" sz="1200" b="1" dirty="0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en-US" sz="1200" b="1" dirty="0" smtClean="0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Times New Roman"/>
                        </a:rPr>
                        <a:t> 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latin typeface="Arial"/>
                          <a:ea typeface="Calibri"/>
                          <a:cs typeface="Times New Roman"/>
                        </a:rPr>
                        <a:t>KA-induced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Arial"/>
                          <a:ea typeface="Calibri"/>
                          <a:cs typeface="Times New Roman"/>
                        </a:rPr>
                        <a:t>editing of AMPA/KA glutamate receptor subunits in </a:t>
                      </a:r>
                      <a:endParaRPr lang="it-IT" sz="1200" dirty="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just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Arial"/>
                          <a:ea typeface="Calibri"/>
                          <a:cs typeface="Times New Roman"/>
                        </a:rPr>
                        <a:t>                 the hippocampus and cortex of COX-2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Arial"/>
                          <a:ea typeface="Calibri"/>
                          <a:cs typeface="Times New Roman"/>
                        </a:rPr>
                        <a:t>+/+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Arial"/>
                          <a:ea typeface="Calibri"/>
                          <a:cs typeface="Times New Roman"/>
                        </a:rPr>
                        <a:t> and COX-2</a:t>
                      </a:r>
                      <a:r>
                        <a:rPr lang="en-US" sz="1200" baseline="30000" dirty="0">
                          <a:solidFill>
                            <a:srgbClr val="000000"/>
                          </a:solidFill>
                          <a:latin typeface="Arial"/>
                          <a:ea typeface="Calibri"/>
                          <a:cs typeface="Times New Roman"/>
                        </a:rPr>
                        <a:t>-/-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latin typeface="Arial"/>
                          <a:ea typeface="Calibri"/>
                          <a:cs typeface="Times New Roman"/>
                        </a:rPr>
                        <a:t> mice.</a:t>
                      </a:r>
                      <a:endParaRPr lang="it-IT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</a:tr>
              <a:tr h="57606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1200"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Editing sites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COX-2</a:t>
                      </a:r>
                      <a:r>
                        <a:rPr lang="en-US" sz="1200" b="1" baseline="30000">
                          <a:latin typeface="Arial"/>
                          <a:ea typeface="Calibri"/>
                          <a:cs typeface="Times New Roman"/>
                        </a:rPr>
                        <a:t>+/+</a:t>
                      </a: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 vehicle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latin typeface="Arial"/>
                          <a:ea typeface="Calibri"/>
                          <a:cs typeface="Times New Roman"/>
                        </a:rPr>
                        <a:t>COX-2</a:t>
                      </a:r>
                      <a:r>
                        <a:rPr lang="en-US" sz="1200" b="1" baseline="30000" dirty="0">
                          <a:latin typeface="Arial"/>
                          <a:ea typeface="Calibri"/>
                          <a:cs typeface="Times New Roman"/>
                        </a:rPr>
                        <a:t>+/+</a:t>
                      </a:r>
                      <a:r>
                        <a:rPr lang="en-US" sz="1200" b="1" dirty="0">
                          <a:latin typeface="Arial"/>
                          <a:ea typeface="Calibri"/>
                          <a:cs typeface="Times New Roman"/>
                        </a:rPr>
                        <a:t> </a:t>
                      </a:r>
                      <a:endParaRPr lang="en-US" sz="1200" b="1" dirty="0" smtClean="0">
                        <a:latin typeface="Arial"/>
                        <a:ea typeface="Calibri"/>
                        <a:cs typeface="Times New Roman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 smtClean="0">
                          <a:latin typeface="Arial"/>
                          <a:ea typeface="Calibri"/>
                          <a:cs typeface="Times New Roman"/>
                        </a:rPr>
                        <a:t>KA</a:t>
                      </a:r>
                      <a:endParaRPr lang="it-IT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COX-2</a:t>
                      </a:r>
                      <a:r>
                        <a:rPr lang="en-US" sz="1200" b="1" baseline="30000">
                          <a:latin typeface="Arial"/>
                          <a:ea typeface="Calibri"/>
                          <a:cs typeface="Times New Roman"/>
                        </a:rPr>
                        <a:t>-/-</a:t>
                      </a: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 vehicle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COX-2</a:t>
                      </a:r>
                      <a:r>
                        <a:rPr lang="en-US" sz="1200" b="1" baseline="30000">
                          <a:latin typeface="Arial"/>
                          <a:ea typeface="Calibri"/>
                          <a:cs typeface="Times New Roman"/>
                        </a:rPr>
                        <a:t>-/-</a:t>
                      </a: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 KA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5433">
                <a:tc rowSpan="6">
                  <a:txBody>
                    <a:bodyPr/>
                    <a:lstStyle/>
                    <a:p>
                      <a:pPr marL="71755" marR="71755"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 b="1" dirty="0">
                          <a:latin typeface="Arial"/>
                          <a:ea typeface="Calibri"/>
                          <a:cs typeface="Times New Roman"/>
                        </a:rPr>
                        <a:t>Hippocampus</a:t>
                      </a:r>
                      <a:endParaRPr lang="it-IT" sz="1400" b="1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GluR2 R/G flip isoform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57.9 ± 1.0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56.6 ± 1.0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61.8 ± 3.4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61.0 ± 0.9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2639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GluR2 R/G flop isoform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37.7 ± 1.1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38.4 ± 2.4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37.7 ± 1.5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40.7 ± 1.8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5433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GluR5 Q/R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65.4 ± 1.1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65.7 ± 3.9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68.7 ± 2.0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68.0 ± 2.0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5433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GluR6 I/V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79.0 ± 1.4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79.2 ± 1.5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75.6 ± 2.3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78.3 ± 1.3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5433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GluR6 Y/C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89.8 ± 0.3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88.9 ± 0.8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87.5 ± 2.0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86.8 ± 2.2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5433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GluR6 Q/R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89.2 ± 2.1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89.2 ± 2.2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91.7 ± 1.9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latin typeface="Arial"/>
                          <a:ea typeface="Calibri"/>
                          <a:cs typeface="Times New Roman"/>
                        </a:rPr>
                        <a:t>86.9 </a:t>
                      </a:r>
                      <a:r>
                        <a:rPr lang="en-US" sz="1200" dirty="0" smtClean="0">
                          <a:latin typeface="Arial"/>
                          <a:ea typeface="Calibri"/>
                          <a:cs typeface="Times New Roman"/>
                        </a:rPr>
                        <a:t>± 2.0</a:t>
                      </a:r>
                      <a:endParaRPr lang="it-IT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373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it-IT" sz="1200">
                          <a:latin typeface="Calibri"/>
                          <a:ea typeface="Calibri"/>
                          <a:cs typeface="Times New Roman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endParaRPr lang="en-US" sz="1200"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endParaRPr lang="en-US" sz="1200"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endParaRPr lang="en-US" sz="1200"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endParaRPr lang="en-US" sz="1200"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5433">
                <a:tc rowSpan="5">
                  <a:txBody>
                    <a:bodyPr/>
                    <a:lstStyle/>
                    <a:p>
                      <a:pPr marL="71755" marR="71755"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400" b="1" dirty="0">
                          <a:latin typeface="Arial"/>
                          <a:ea typeface="Calibri"/>
                          <a:cs typeface="Times New Roman"/>
                        </a:rPr>
                        <a:t>Cerebral cortex</a:t>
                      </a:r>
                      <a:endParaRPr lang="it-IT" sz="1400" b="1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vert="vert27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GluR2 R/G flip isoform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64.6 ± 5.5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68.2 ± 3.9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67.3 ± 3.0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65.5 ± 4.9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150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GluR2 R/G flop isoform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54.8 ± 1.4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55.3 ± 4.0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53.1 ± 3.6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52.6 ± 2.7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5433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GluR4 R/G flip isoform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52.3 ± 2.8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54.9 ± 2.8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54.8 ± 1.8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52.2 ± 7.2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150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GluR4 R/G flop isoform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78.1 ± 0.9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81.4 ± 2.6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81.0 ± 2.7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81.1 ± 1.8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5433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 b="1">
                          <a:latin typeface="Arial"/>
                          <a:ea typeface="Calibri"/>
                          <a:cs typeface="Times New Roman"/>
                        </a:rPr>
                        <a:t>GluR5 Q/R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69.9 ± 1.8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73.4 ± 2.3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72.6 ± 2.1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latin typeface="Arial"/>
                          <a:ea typeface="Calibri"/>
                          <a:cs typeface="Times New Roman"/>
                        </a:rPr>
                        <a:t>70.3 ± 3.3</a:t>
                      </a:r>
                      <a:endParaRPr lang="it-IT" sz="12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03964">
                <a:tc gridSpan="6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200" i="1" dirty="0">
                          <a:latin typeface="Arial"/>
                          <a:ea typeface="Calibri"/>
                          <a:cs typeface="Times New Roman"/>
                        </a:rPr>
                        <a:t>Data are Means ± SEM expressed as % editing level compared to their controls. Statistical analysis was performed with Student’s test.</a:t>
                      </a:r>
                      <a:endParaRPr lang="it-IT" sz="12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30142" marR="30142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5</TotalTime>
  <Words>230</Words>
  <Application>Microsoft Office PowerPoint</Application>
  <PresentationFormat>On-screen Show (4:3)</PresentationFormat>
  <Paragraphs>7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i Office</vt:lpstr>
      <vt:lpstr>Slide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luca</dc:creator>
  <cp:lastModifiedBy>caracciolol</cp:lastModifiedBy>
  <cp:revision>13</cp:revision>
  <dcterms:created xsi:type="dcterms:W3CDTF">2010-11-30T21:28:50Z</dcterms:created>
  <dcterms:modified xsi:type="dcterms:W3CDTF">2011-04-05T20:40:13Z</dcterms:modified>
</cp:coreProperties>
</file>